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7200900" cy="10801350"/>
  <p:notesSz cx="6858000" cy="9144000"/>
  <p:defaultTextStyle>
    <a:defPPr>
      <a:defRPr lang="ja-JP"/>
    </a:defPPr>
    <a:lvl1pPr marL="0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1pPr>
    <a:lvl2pPr marL="349717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2pPr>
    <a:lvl3pPr marL="699432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3pPr>
    <a:lvl4pPr marL="1049148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4pPr>
    <a:lvl5pPr marL="1398865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5pPr>
    <a:lvl6pPr marL="1748581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6pPr>
    <a:lvl7pPr marL="2098296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7pPr>
    <a:lvl8pPr marL="2448013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8pPr>
    <a:lvl9pPr marL="2797730" algn="l" defTabSz="699432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8">
          <p15:clr>
            <a:srgbClr val="A4A3A4"/>
          </p15:clr>
        </p15:guide>
        <p15:guide id="2" pos="2268">
          <p15:clr>
            <a:srgbClr val="A4A3A4"/>
          </p15:clr>
        </p15:guide>
        <p15:guide id="3" orient="horz" pos="340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3276" y="78"/>
      </p:cViewPr>
      <p:guideLst>
        <p:guide orient="horz" pos="1588"/>
        <p:guide pos="2268"/>
        <p:guide orient="horz" pos="340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247ABF-611E-43A8-9657-6603A7A3CAAE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685800"/>
            <a:ext cx="228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8D0AF8-7210-4139-A44C-0F37922F6A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06414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86000" y="685800"/>
            <a:ext cx="2286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8D0AF8-7210-4139-A44C-0F37922F6A4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98187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40070" y="3355423"/>
            <a:ext cx="6120765" cy="2315288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80135" y="6120764"/>
            <a:ext cx="504063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97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9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49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98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48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982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48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977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220655" y="432559"/>
            <a:ext cx="1620203" cy="9216151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60048" y="432559"/>
            <a:ext cx="4740593" cy="9216151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8824" y="6940872"/>
            <a:ext cx="6120765" cy="2145268"/>
          </a:xfrm>
        </p:spPr>
        <p:txBody>
          <a:bodyPr anchor="t"/>
          <a:lstStyle>
            <a:lvl1pPr algn="l">
              <a:defRPr sz="31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68824" y="4578074"/>
            <a:ext cx="6120765" cy="2362794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97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94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4914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9886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4858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9829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4801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9773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60045" y="2520318"/>
            <a:ext cx="3180398" cy="712839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660457" y="2520318"/>
            <a:ext cx="3180398" cy="712839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60045" y="2417806"/>
            <a:ext cx="3181648" cy="100762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9717" indent="0">
              <a:buNone/>
              <a:defRPr sz="1500" b="1"/>
            </a:lvl2pPr>
            <a:lvl3pPr marL="699432" indent="0">
              <a:buNone/>
              <a:defRPr sz="1400" b="1"/>
            </a:lvl3pPr>
            <a:lvl4pPr marL="1049148" indent="0">
              <a:buNone/>
              <a:defRPr sz="1200" b="1"/>
            </a:lvl4pPr>
            <a:lvl5pPr marL="1398865" indent="0">
              <a:buNone/>
              <a:defRPr sz="1200" b="1"/>
            </a:lvl5pPr>
            <a:lvl6pPr marL="1748581" indent="0">
              <a:buNone/>
              <a:defRPr sz="1200" b="1"/>
            </a:lvl6pPr>
            <a:lvl7pPr marL="2098296" indent="0">
              <a:buNone/>
              <a:defRPr sz="1200" b="1"/>
            </a:lvl7pPr>
            <a:lvl8pPr marL="2448013" indent="0">
              <a:buNone/>
              <a:defRPr sz="1200" b="1"/>
            </a:lvl8pPr>
            <a:lvl9pPr marL="279773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60045" y="3425429"/>
            <a:ext cx="3181648" cy="622327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657958" y="2417806"/>
            <a:ext cx="3182898" cy="100762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9717" indent="0">
              <a:buNone/>
              <a:defRPr sz="1500" b="1"/>
            </a:lvl2pPr>
            <a:lvl3pPr marL="699432" indent="0">
              <a:buNone/>
              <a:defRPr sz="1400" b="1"/>
            </a:lvl3pPr>
            <a:lvl4pPr marL="1049148" indent="0">
              <a:buNone/>
              <a:defRPr sz="1200" b="1"/>
            </a:lvl4pPr>
            <a:lvl5pPr marL="1398865" indent="0">
              <a:buNone/>
              <a:defRPr sz="1200" b="1"/>
            </a:lvl5pPr>
            <a:lvl6pPr marL="1748581" indent="0">
              <a:buNone/>
              <a:defRPr sz="1200" b="1"/>
            </a:lvl6pPr>
            <a:lvl7pPr marL="2098296" indent="0">
              <a:buNone/>
              <a:defRPr sz="1200" b="1"/>
            </a:lvl7pPr>
            <a:lvl8pPr marL="2448013" indent="0">
              <a:buNone/>
              <a:defRPr sz="1200" b="1"/>
            </a:lvl8pPr>
            <a:lvl9pPr marL="279773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657958" y="3425429"/>
            <a:ext cx="3182898" cy="6223279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60048" y="430055"/>
            <a:ext cx="2369047" cy="1830229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815355" y="430056"/>
            <a:ext cx="4025503" cy="921865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60048" y="2260287"/>
            <a:ext cx="2369047" cy="7388423"/>
          </a:xfrm>
        </p:spPr>
        <p:txBody>
          <a:bodyPr/>
          <a:lstStyle>
            <a:lvl1pPr marL="0" indent="0">
              <a:buNone/>
              <a:defRPr sz="1100"/>
            </a:lvl1pPr>
            <a:lvl2pPr marL="349717" indent="0">
              <a:buNone/>
              <a:defRPr sz="900"/>
            </a:lvl2pPr>
            <a:lvl3pPr marL="699432" indent="0">
              <a:buNone/>
              <a:defRPr sz="800"/>
            </a:lvl3pPr>
            <a:lvl4pPr marL="1049148" indent="0">
              <a:buNone/>
              <a:defRPr sz="700"/>
            </a:lvl4pPr>
            <a:lvl5pPr marL="1398865" indent="0">
              <a:buNone/>
              <a:defRPr sz="700"/>
            </a:lvl5pPr>
            <a:lvl6pPr marL="1748581" indent="0">
              <a:buNone/>
              <a:defRPr sz="700"/>
            </a:lvl6pPr>
            <a:lvl7pPr marL="2098296" indent="0">
              <a:buNone/>
              <a:defRPr sz="700"/>
            </a:lvl7pPr>
            <a:lvl8pPr marL="2448013" indent="0">
              <a:buNone/>
              <a:defRPr sz="700"/>
            </a:lvl8pPr>
            <a:lvl9pPr marL="2797730" indent="0">
              <a:buNone/>
              <a:defRPr sz="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11427" y="7560948"/>
            <a:ext cx="4320540" cy="89261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411427" y="965120"/>
            <a:ext cx="4320540" cy="6480811"/>
          </a:xfrm>
        </p:spPr>
        <p:txBody>
          <a:bodyPr/>
          <a:lstStyle>
            <a:lvl1pPr marL="0" indent="0">
              <a:buNone/>
              <a:defRPr sz="2400"/>
            </a:lvl1pPr>
            <a:lvl2pPr marL="349717" indent="0">
              <a:buNone/>
              <a:defRPr sz="2100"/>
            </a:lvl2pPr>
            <a:lvl3pPr marL="699432" indent="0">
              <a:buNone/>
              <a:defRPr sz="1800"/>
            </a:lvl3pPr>
            <a:lvl4pPr marL="1049148" indent="0">
              <a:buNone/>
              <a:defRPr sz="1500"/>
            </a:lvl4pPr>
            <a:lvl5pPr marL="1398865" indent="0">
              <a:buNone/>
              <a:defRPr sz="1500"/>
            </a:lvl5pPr>
            <a:lvl6pPr marL="1748581" indent="0">
              <a:buNone/>
              <a:defRPr sz="1500"/>
            </a:lvl6pPr>
            <a:lvl7pPr marL="2098296" indent="0">
              <a:buNone/>
              <a:defRPr sz="1500"/>
            </a:lvl7pPr>
            <a:lvl8pPr marL="2448013" indent="0">
              <a:buNone/>
              <a:defRPr sz="1500"/>
            </a:lvl8pPr>
            <a:lvl9pPr marL="279773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11427" y="8453559"/>
            <a:ext cx="4320540" cy="1267657"/>
          </a:xfrm>
        </p:spPr>
        <p:txBody>
          <a:bodyPr/>
          <a:lstStyle>
            <a:lvl1pPr marL="0" indent="0">
              <a:buNone/>
              <a:defRPr sz="1100"/>
            </a:lvl1pPr>
            <a:lvl2pPr marL="349717" indent="0">
              <a:buNone/>
              <a:defRPr sz="900"/>
            </a:lvl2pPr>
            <a:lvl3pPr marL="699432" indent="0">
              <a:buNone/>
              <a:defRPr sz="800"/>
            </a:lvl3pPr>
            <a:lvl4pPr marL="1049148" indent="0">
              <a:buNone/>
              <a:defRPr sz="700"/>
            </a:lvl4pPr>
            <a:lvl5pPr marL="1398865" indent="0">
              <a:buNone/>
              <a:defRPr sz="700"/>
            </a:lvl5pPr>
            <a:lvl6pPr marL="1748581" indent="0">
              <a:buNone/>
              <a:defRPr sz="700"/>
            </a:lvl6pPr>
            <a:lvl7pPr marL="2098296" indent="0">
              <a:buNone/>
              <a:defRPr sz="700"/>
            </a:lvl7pPr>
            <a:lvl8pPr marL="2448013" indent="0">
              <a:buNone/>
              <a:defRPr sz="700"/>
            </a:lvl8pPr>
            <a:lvl9pPr marL="2797730" indent="0">
              <a:buNone/>
              <a:defRPr sz="7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60045" y="432554"/>
            <a:ext cx="6480810" cy="1800225"/>
          </a:xfrm>
          <a:prstGeom prst="rect">
            <a:avLst/>
          </a:prstGeom>
        </p:spPr>
        <p:txBody>
          <a:bodyPr vert="horz" lIns="69944" tIns="34971" rIns="69944" bIns="34971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60045" y="2520318"/>
            <a:ext cx="6480810" cy="7128392"/>
          </a:xfrm>
          <a:prstGeom prst="rect">
            <a:avLst/>
          </a:prstGeom>
        </p:spPr>
        <p:txBody>
          <a:bodyPr vert="horz" lIns="69944" tIns="34971" rIns="69944" bIns="34971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60045" y="10011255"/>
            <a:ext cx="1680210" cy="575072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8/1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460310" y="10011255"/>
            <a:ext cx="2280285" cy="575072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5160645" y="10011255"/>
            <a:ext cx="1680210" cy="575072"/>
          </a:xfrm>
          <a:prstGeom prst="rect">
            <a:avLst/>
          </a:prstGeom>
        </p:spPr>
        <p:txBody>
          <a:bodyPr vert="horz" lIns="69944" tIns="34971" rIns="69944" bIns="3497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9432" rtl="0" eaLnBrk="1" latinLnBrk="0" hangingPunct="1">
        <a:spcBef>
          <a:spcPct val="0"/>
        </a:spcBef>
        <a:buNone/>
        <a:defRPr kumimoji="1" sz="3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2287" indent="-262287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8290" indent="-218573" algn="l" defTabSz="699432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74291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24007" indent="-174858" algn="l" defTabSz="699432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73722" indent="-174858" algn="l" defTabSz="699432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23439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73155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22871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72587" indent="-174858" algn="l" defTabSz="699432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9717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9432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9148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98865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48581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98296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48013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97730" algn="l" defTabSz="699432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/>
          <p:cNvSpPr txBox="1"/>
          <p:nvPr/>
        </p:nvSpPr>
        <p:spPr>
          <a:xfrm>
            <a:off x="143378" y="119980"/>
            <a:ext cx="1350035" cy="415492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21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ja-JP" altLang="en-US" sz="2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4175" y="483100"/>
            <a:ext cx="1072715" cy="33854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Wild mic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369" y="788525"/>
            <a:ext cx="6687175" cy="18270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0" name="テキスト ボックス 49"/>
          <p:cNvSpPr txBox="1"/>
          <p:nvPr/>
        </p:nvSpPr>
        <p:spPr>
          <a:xfrm>
            <a:off x="44175" y="2730558"/>
            <a:ext cx="914019" cy="33854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g mice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369" y="3069107"/>
            <a:ext cx="6687175" cy="18995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2" name="テキスト ボックス 51"/>
          <p:cNvSpPr txBox="1"/>
          <p:nvPr/>
        </p:nvSpPr>
        <p:spPr>
          <a:xfrm>
            <a:off x="44175" y="5134135"/>
            <a:ext cx="3637200" cy="33854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solated pBNP-tdTomato-positive cells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369" y="5616699"/>
            <a:ext cx="6687175" cy="1886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6" name="テキスト ボックス 55"/>
          <p:cNvSpPr txBox="1"/>
          <p:nvPr/>
        </p:nvSpPr>
        <p:spPr>
          <a:xfrm>
            <a:off x="44175" y="7654415"/>
            <a:ext cx="3717350" cy="338548"/>
          </a:xfrm>
          <a:prstGeom prst="rect">
            <a:avLst/>
          </a:prstGeom>
          <a:noFill/>
        </p:spPr>
        <p:txBody>
          <a:bodyPr wrap="none" lIns="91433" tIns="45717" rIns="91433" bIns="45717" rtlCol="0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Isolated pBNP-tdTomato-negative cells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138"/>
          <a:stretch/>
        </p:blipFill>
        <p:spPr bwMode="auto">
          <a:xfrm>
            <a:off x="341530" y="8058015"/>
            <a:ext cx="6700014" cy="18439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98983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kumimoji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13</Words>
  <Application>Microsoft Office PowerPoint</Application>
  <PresentationFormat>ユーザー設定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kamoto</dc:creator>
  <cp:lastModifiedBy>岡本隆二</cp:lastModifiedBy>
  <cp:revision>139</cp:revision>
  <dcterms:created xsi:type="dcterms:W3CDTF">2016-10-09T08:46:23Z</dcterms:created>
  <dcterms:modified xsi:type="dcterms:W3CDTF">2018-01-03T02:03:53Z</dcterms:modified>
</cp:coreProperties>
</file>